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03" r:id="rId2"/>
  </p:sldIdLst>
  <p:sldSz cx="6858000" cy="9906000" type="A4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602" autoAdjust="0"/>
    <p:restoredTop sz="99872" autoAdjust="0"/>
  </p:normalViewPr>
  <p:slideViewPr>
    <p:cSldViewPr>
      <p:cViewPr>
        <p:scale>
          <a:sx n="100" d="100"/>
          <a:sy n="100" d="100"/>
        </p:scale>
        <p:origin x="-2064" y="214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45005" cy="450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7257D7-D7BE-4475-912D-A861A539B70E}" type="datetimeFigureOut">
              <a:rPr lang="it-IT" smtClean="0"/>
              <a:t>27/11/2015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9671"/>
            <a:ext cx="2946400" cy="4969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429671"/>
            <a:ext cx="2946400" cy="4969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B067331-E300-493D-B25C-E95C2384BC29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194881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5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4DDC09-3A55-4B16-AD34-7AD3F499AB41}" type="datetimeFigureOut">
              <a:rPr lang="it-IT" smtClean="0"/>
              <a:t>27/11/2015</a:t>
            </a:fld>
            <a:endParaRPr lang="it-I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49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8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5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1D5D10-F67F-430D-926A-A83F6D16763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108719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None/>
            </a:pPr>
            <a:endParaRPr lang="it-I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F1D5D10-F67F-430D-926A-A83F6D16763D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581126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9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7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7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92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13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402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1/2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402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402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 descr="F:\Lab\IF da settembre 2013\20150303_revisioneTNKS_APC 1st exp\ACQUISIZIONI FINALI\APC\300 dpi\1-scramble T0_ProjMax001_ch00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92341" y="435495"/>
            <a:ext cx="1446552" cy="14465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4" descr="F:\Lab\IF da settembre 2013\20150303_revisioneTNKS_APC 1st exp\ACQUISIZIONI FINALI\APC\300 dpi\2-shTNKS T0_ProjMax001_ch00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51041" y="435495"/>
            <a:ext cx="1446552" cy="14465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6" descr="F:\Lab\IF da settembre 2013\20150303_revisioneTNKS_APC 1st exp\ACQUISIZIONI FINALI\APC\300 dpi\3-scramble 15 min_ProjMax001_ch00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0800000">
            <a:off x="1892342" y="1891765"/>
            <a:ext cx="1446552" cy="14465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7" descr="F:\Lab\IF da settembre 2013\20150303_revisioneTNKS_APC 1st exp\ACQUISIZIONI FINALI\APC\300 dpi\6-shTNKS 30 min_ProjMax001_ch00.ti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51041" y="3352894"/>
            <a:ext cx="1446552" cy="14465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8" descr="F:\Lab\IF da settembre 2013\20150303_revisioneTNKS_APC 1st exp\ACQUISIZIONI FINALI\APC\300 dpi\5-scramble 30 min_ProjMax001_ch00.tif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 flipH="1">
            <a:off x="1892341" y="3352894"/>
            <a:ext cx="1446552" cy="14465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9" descr="F:\Lab\IF da settembre 2013\20150303_revisioneTNKS_APC 1st exp\ACQUISIZIONI FINALI\APC\300 dpi\8-shTNKS 60 min_02_ProjMax001_ch00.tif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3351041" y="4811593"/>
            <a:ext cx="1446552" cy="14465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10" descr="F:\Lab\IF da settembre 2013\20150303_revisioneTNKS_APC 1st exp\ACQUISIZIONI FINALI\APC\300 dpi\7-scramble 60 min_ProjMax001_ch00.tif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0800000">
            <a:off x="1892341" y="4811592"/>
            <a:ext cx="1446552" cy="14465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11" descr="F:\Lab\IF da settembre 2013\20150303_revisioneTNKS_APC 1st exp\ACQUISIZIONI FINALI\APC\300 dpi\04-shTNKS_APC 15 min_01_ProjMax001_ch00.tif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51041" y="1891765"/>
            <a:ext cx="1446552" cy="14465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Text Box 26"/>
          <p:cNvSpPr txBox="1">
            <a:spLocks noChangeArrowheads="1"/>
          </p:cNvSpPr>
          <p:nvPr/>
        </p:nvSpPr>
        <p:spPr bwMode="auto">
          <a:xfrm>
            <a:off x="2221711" y="189378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 Box 26"/>
          <p:cNvSpPr txBox="1">
            <a:spLocks noChangeArrowheads="1"/>
          </p:cNvSpPr>
          <p:nvPr/>
        </p:nvSpPr>
        <p:spPr bwMode="auto">
          <a:xfrm>
            <a:off x="3519009" y="189378"/>
            <a:ext cx="1072273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NKS1/2 </a:t>
            </a:r>
            <a:r>
              <a:rPr lang="en-US" altLang="it-IT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RNA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 Box 26"/>
          <p:cNvSpPr txBox="1">
            <a:spLocks noChangeArrowheads="1"/>
          </p:cNvSpPr>
          <p:nvPr/>
        </p:nvSpPr>
        <p:spPr bwMode="auto">
          <a:xfrm>
            <a:off x="1376455" y="1041554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 Box 26"/>
          <p:cNvSpPr txBox="1">
            <a:spLocks noChangeArrowheads="1"/>
          </p:cNvSpPr>
          <p:nvPr/>
        </p:nvSpPr>
        <p:spPr bwMode="auto">
          <a:xfrm>
            <a:off x="1376456" y="2500538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 Box 26"/>
          <p:cNvSpPr txBox="1">
            <a:spLocks noChangeArrowheads="1"/>
          </p:cNvSpPr>
          <p:nvPr/>
        </p:nvSpPr>
        <p:spPr bwMode="auto">
          <a:xfrm>
            <a:off x="1376455" y="5418508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 Box 26"/>
          <p:cNvSpPr txBox="1">
            <a:spLocks noChangeArrowheads="1"/>
          </p:cNvSpPr>
          <p:nvPr/>
        </p:nvSpPr>
        <p:spPr bwMode="auto">
          <a:xfrm>
            <a:off x="1376456" y="3959522"/>
            <a:ext cx="75723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Left Bracket 23"/>
          <p:cNvSpPr/>
          <p:nvPr/>
        </p:nvSpPr>
        <p:spPr>
          <a:xfrm>
            <a:off x="1590346" y="426144"/>
            <a:ext cx="108000" cy="5832000"/>
          </a:xfrm>
          <a:prstGeom prst="leftBracket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5" name="Text Box 26"/>
          <p:cNvSpPr txBox="1">
            <a:spLocks noChangeArrowheads="1"/>
          </p:cNvSpPr>
          <p:nvPr/>
        </p:nvSpPr>
        <p:spPr bwMode="auto">
          <a:xfrm rot="16200000">
            <a:off x="667600" y="3309380"/>
            <a:ext cx="161317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altLang="it-IT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HGF stimulation (min)</a:t>
            </a:r>
            <a:endParaRPr lang="en-US" alt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35"/>
          <p:cNvSpPr txBox="1"/>
          <p:nvPr/>
        </p:nvSpPr>
        <p:spPr>
          <a:xfrm>
            <a:off x="491091" y="6978225"/>
            <a:ext cx="585065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8: </a:t>
            </a:r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it-IT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7.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NKS silencing prevents the reallocation of APC at cortical sites </a:t>
            </a:r>
          </a:p>
          <a:p>
            <a:pPr algn="just">
              <a:lnSpc>
                <a:spcPct val="150000"/>
              </a:lnSpc>
            </a:pPr>
            <a:endParaRPr lang="en-US" sz="1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549 cells transduced with either control (mock) or TNKS1/2-directed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RNAs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were serum-starved and scratched with a pipette tip prior to treatment with HGF (HGF, 50 ng/ml) for 4 h. Cells were then fixed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nd stained with anti‑APC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ntibody. Illustrative confocal images taken at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e indicated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ntervals are representative of one experiment out of two independent ones. Scale bar, 7 </a:t>
            </a:r>
            <a:r>
              <a:rPr lang="en-US" sz="1000" dirty="0" smtClean="0">
                <a:latin typeface="Symbol" panose="05050102010706020507" pitchFamily="18" charset="2"/>
                <a:cs typeface="Arial" panose="020B0604020202020204" pitchFamily="34" charset="0"/>
              </a:rPr>
              <a:t>m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.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Connettore 1 35"/>
          <p:cNvCxnSpPr/>
          <p:nvPr/>
        </p:nvCxnSpPr>
        <p:spPr>
          <a:xfrm>
            <a:off x="1943835" y="1802650"/>
            <a:ext cx="9144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4284095" y="9481294"/>
            <a:ext cx="24497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upo et al., 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8: </a:t>
            </a:r>
            <a:r>
              <a:rPr lang="it-IT" sz="10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it-IT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7</a:t>
            </a:r>
            <a:endParaRPr lang="it-IT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19889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1994</TotalTime>
  <Words>110</Words>
  <Application>Microsoft Office PowerPoint</Application>
  <PresentationFormat>A4 Paper (210x297 mm)</PresentationFormat>
  <Paragraphs>1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bara Lupo</dc:creator>
  <cp:lastModifiedBy>ltrusolino</cp:lastModifiedBy>
  <cp:revision>531</cp:revision>
  <cp:lastPrinted>2014-11-07T12:40:06Z</cp:lastPrinted>
  <dcterms:created xsi:type="dcterms:W3CDTF">2006-08-16T00:00:00Z</dcterms:created>
  <dcterms:modified xsi:type="dcterms:W3CDTF">2015-11-27T18:29:53Z</dcterms:modified>
</cp:coreProperties>
</file>